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>
        <p:scale>
          <a:sx n="112" d="100"/>
          <a:sy n="112" d="100"/>
        </p:scale>
        <p:origin x="144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DC7C8-0218-5E4A-8933-B4F170B3C5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2702A4-B2DF-B24B-9E18-DC21A364C6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5AD5F6-98FE-374B-AC59-FC266D4E9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F64EA3-6952-7040-8728-D038EB283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642315-D8F7-D248-8989-3C1B7E19D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31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44584F-1CDF-A04C-AC35-B2A683464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AA04A5-5FD8-DE48-AAAB-5BEDE7DEE2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AAA59-2B14-C446-81A3-4CA2564C9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E8EE36-9884-1F48-88F8-77A351F6C8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20CDB5-4603-AF40-B401-2DE8751AF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044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51D0E4D-581E-A04A-978D-73185D76D2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07BFFC-8E71-6B4D-9D71-CCA84E52D0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88BA71-D809-A847-A34E-48E8319FE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0CA9C7-D213-914F-9912-4A42A6B2A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1B77C2-CCCD-4A48-B7DE-EDB71C78F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654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06DE88-8D46-934D-9A1E-F4FC851477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ED0614-278B-C941-9DBB-9EFA62C011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4CD90C-1D3E-C445-9E62-1108C9CC4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747347-7A86-D14D-9D57-AE3862E22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9D4E67-409F-454F-BCEE-C1D29C52E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937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E23A90-18B8-1846-8542-B9E3E1020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0A6285-BC34-9E4E-A590-BBDA61C427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34B231-BE86-0C40-AA40-B06C505B75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59EAC2-B8D2-9E42-8479-6C1DD5585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EECDAF-DA36-C34F-82CD-1B1B984D1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595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F031A6-3F76-9E4F-82F3-2190B8D44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C22A1F-EE8F-3A46-B5E4-9303B26CD1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234755-FA2F-4347-B512-43B47F2560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4BAC8C-0515-FC49-9F92-06775BEBB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5B1ABF-50BE-3B49-9931-E6159162A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7BCD80-7FE7-3444-8287-9102B9509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24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50C0E4-87AD-364F-8076-38EDA69400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90ACB5-3B3E-F248-B8FA-67C1E9FCEB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D89C6E-1DE5-D44A-9D60-5A1EF7AD60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064249B-20BA-7640-A6C3-91A17189C3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E1709F8-C326-7047-9AAD-E63FEFF4E3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1387BD-0219-2C4F-B78A-AAFB0AC37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0F56E2-87E0-0A46-A6F2-31F68A0CA0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EC8785-A92B-5347-A8FC-46568F3D9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633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66471E-C805-A94E-8507-1E20C75D8A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1F9A06-CB52-F14E-AF7F-5E6A5A12B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DB3F3A-1196-5D4D-8DA3-5DFBE7DEB3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A0375C5-D8DA-7843-B36E-0B184B00D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591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8C4220-F26B-0046-9FAE-06408A9D8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34E9C0-7766-D34F-BF5B-DB8F20B9E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5E06D9-72C8-084B-8E6F-AAC79EB49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682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4B22AA-0A6C-7D42-88A3-8ED37092E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1D916D-A464-8A44-8F7C-E368938DE4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4F8B82-6452-6141-B6AB-32401FDAC0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9733A4-DD1C-DF45-B188-C345C01459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407862-B0CD-7443-BFDC-49203A531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0F29FB-2E5A-A149-B71D-56F310972D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856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45633A-F7B4-D541-8539-F0FFEBBB48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D9613F-C5BB-0B41-B626-0A291E8672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EB095B-9CF3-614A-B76B-82E2A2390B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A76CDE-1DBD-B64C-A318-DADA483D9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1863DB-2DA7-2D47-87C1-7AC950FA6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58E4A9-DD9A-F94D-8E6A-E07CDBBDA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17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9D5D85-DFC7-474B-9366-903D87432F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1CA759-9351-EF4D-8883-F59DD76BF2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41155B-8F23-6D46-8D29-1EE37B210D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369D54-CC6D-904C-95F3-D3665757F8E7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D070D-DC13-6644-B609-C5E60E2422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69BF67-55A9-304E-A7FE-06F36F1433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E57246-7A22-AF4B-A65E-27A314570A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308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942C563F-4EA2-6343-B028-E90F51477E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9260" y="984738"/>
            <a:ext cx="4474866" cy="5873262"/>
          </a:xfrm>
          <a:prstGeom prst="rect">
            <a:avLst/>
          </a:prstGeom>
        </p:spPr>
      </p:pic>
      <p:pic>
        <p:nvPicPr>
          <p:cNvPr id="7" name="Picture 6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E0A7D893-94DC-6F47-A0C2-F3DA993965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34402" y="984738"/>
            <a:ext cx="4474866" cy="587326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2D41237-575A-E14A-AA23-782F7BF38955}"/>
              </a:ext>
            </a:extLst>
          </p:cNvPr>
          <p:cNvSpPr txBox="1"/>
          <p:nvPr/>
        </p:nvSpPr>
        <p:spPr>
          <a:xfrm>
            <a:off x="1850917" y="450165"/>
            <a:ext cx="3993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-HCT116 no </a:t>
            </a:r>
            <a:r>
              <a:rPr lang="en-US" dirty="0" err="1"/>
              <a:t>treatment_p</a:t>
            </a:r>
            <a:r>
              <a:rPr lang="en-US" dirty="0"/>
              <a:t>-ATM(S1981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A9F250-A94F-904F-B9DA-BF5C5D513013}"/>
              </a:ext>
            </a:extLst>
          </p:cNvPr>
          <p:cNvSpPr txBox="1"/>
          <p:nvPr/>
        </p:nvSpPr>
        <p:spPr>
          <a:xfrm>
            <a:off x="6810570" y="480085"/>
            <a:ext cx="3726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-HCT116 </a:t>
            </a:r>
            <a:r>
              <a:rPr lang="en-US" dirty="0" err="1"/>
              <a:t>Dox+auxin_p-ATM</a:t>
            </a:r>
            <a:r>
              <a:rPr lang="en-US" dirty="0"/>
              <a:t>(S1981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4259855-2F01-AC4A-93EE-CB09873D458B}"/>
              </a:ext>
            </a:extLst>
          </p:cNvPr>
          <p:cNvSpPr/>
          <p:nvPr/>
        </p:nvSpPr>
        <p:spPr>
          <a:xfrm>
            <a:off x="2046351" y="3612759"/>
            <a:ext cx="2183130" cy="18736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E3E3CAD6-2077-A146-941E-E31757466BE1}"/>
              </a:ext>
            </a:extLst>
          </p:cNvPr>
          <p:cNvSpPr/>
          <p:nvPr/>
        </p:nvSpPr>
        <p:spPr>
          <a:xfrm>
            <a:off x="8639610" y="4279509"/>
            <a:ext cx="2183130" cy="18736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6782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EE61D19E-6CD9-4A44-AFD2-296651AB8E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4589" y="925830"/>
            <a:ext cx="4415246" cy="5795010"/>
          </a:xfrm>
          <a:prstGeom prst="rect">
            <a:avLst/>
          </a:prstGeom>
        </p:spPr>
      </p:pic>
      <p:pic>
        <p:nvPicPr>
          <p:cNvPr id="5" name="Picture 4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47E2D098-99C3-9849-9355-108372CABD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58099" y="925830"/>
            <a:ext cx="4415246" cy="57950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9010A98-B08F-2447-AE81-5352F1F4E6B8}"/>
              </a:ext>
            </a:extLst>
          </p:cNvPr>
          <p:cNvSpPr txBox="1"/>
          <p:nvPr/>
        </p:nvSpPr>
        <p:spPr>
          <a:xfrm>
            <a:off x="1542066" y="526578"/>
            <a:ext cx="3895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</a:t>
            </a:r>
            <a:r>
              <a:rPr lang="en-US" dirty="0" err="1"/>
              <a:t>treatment_p</a:t>
            </a:r>
            <a:r>
              <a:rPr lang="en-US" dirty="0"/>
              <a:t>-ATM(S1981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446BB7-3265-6E43-A34E-5897680ADA02}"/>
              </a:ext>
            </a:extLst>
          </p:cNvPr>
          <p:cNvSpPr txBox="1"/>
          <p:nvPr/>
        </p:nvSpPr>
        <p:spPr>
          <a:xfrm>
            <a:off x="7130750" y="556498"/>
            <a:ext cx="3726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_p-ATM</a:t>
            </a:r>
            <a:r>
              <a:rPr lang="en-US" dirty="0"/>
              <a:t>(S1981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8CD1132-E0F3-C74A-A905-2F249293B1EE}"/>
              </a:ext>
            </a:extLst>
          </p:cNvPr>
          <p:cNvSpPr/>
          <p:nvPr/>
        </p:nvSpPr>
        <p:spPr>
          <a:xfrm>
            <a:off x="1988820" y="2138289"/>
            <a:ext cx="2183130" cy="18736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39E33A2-2A3F-D249-BE0F-3BC88677BA97}"/>
              </a:ext>
            </a:extLst>
          </p:cNvPr>
          <p:cNvSpPr/>
          <p:nvPr/>
        </p:nvSpPr>
        <p:spPr>
          <a:xfrm>
            <a:off x="6970830" y="2633589"/>
            <a:ext cx="2183130" cy="18736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563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226A3B4D-DEFA-ED4C-9CAD-B25811E6A5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1546" y="982980"/>
            <a:ext cx="4476206" cy="5875020"/>
          </a:xfrm>
          <a:prstGeom prst="rect">
            <a:avLst/>
          </a:prstGeom>
        </p:spPr>
      </p:pic>
      <p:pic>
        <p:nvPicPr>
          <p:cNvPr id="5" name="Picture 4" descr="A screenshot of a video game&#10;&#10;Description automatically generated with medium confidence">
            <a:extLst>
              <a:ext uri="{FF2B5EF4-FFF2-40B4-BE49-F238E27FC236}">
                <a16:creationId xmlns:a16="http://schemas.microsoft.com/office/drawing/2014/main" id="{1BF4452B-D986-1E4B-8E86-E363182200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26679" y="982980"/>
            <a:ext cx="4476206" cy="58750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67D5632-8743-994D-ABBA-E11EB8DFA021}"/>
              </a:ext>
            </a:extLst>
          </p:cNvPr>
          <p:cNvSpPr txBox="1"/>
          <p:nvPr/>
        </p:nvSpPr>
        <p:spPr>
          <a:xfrm>
            <a:off x="1542066" y="526578"/>
            <a:ext cx="3895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4 no </a:t>
            </a:r>
            <a:r>
              <a:rPr lang="en-US" dirty="0" err="1"/>
              <a:t>treatment_p</a:t>
            </a:r>
            <a:r>
              <a:rPr lang="en-US" dirty="0"/>
              <a:t>-ATM(S1981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E2178FB-AF1E-3442-92CD-7C2CF8E7435A}"/>
              </a:ext>
            </a:extLst>
          </p:cNvPr>
          <p:cNvSpPr txBox="1"/>
          <p:nvPr/>
        </p:nvSpPr>
        <p:spPr>
          <a:xfrm>
            <a:off x="7130750" y="556498"/>
            <a:ext cx="3629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4 </a:t>
            </a:r>
            <a:r>
              <a:rPr lang="en-US" dirty="0" err="1"/>
              <a:t>Dox+auxin_p-ATM</a:t>
            </a:r>
            <a:r>
              <a:rPr lang="en-US" dirty="0"/>
              <a:t>(S1981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491937C-6DDC-1540-943E-D8D548FB07DE}"/>
              </a:ext>
            </a:extLst>
          </p:cNvPr>
          <p:cNvSpPr/>
          <p:nvPr/>
        </p:nvSpPr>
        <p:spPr>
          <a:xfrm>
            <a:off x="1703451" y="3544179"/>
            <a:ext cx="2183130" cy="18736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8F38A17-709A-CE46-A5DD-177FA87B04B5}"/>
              </a:ext>
            </a:extLst>
          </p:cNvPr>
          <p:cNvSpPr/>
          <p:nvPr/>
        </p:nvSpPr>
        <p:spPr>
          <a:xfrm>
            <a:off x="7622340" y="3521318"/>
            <a:ext cx="2183130" cy="18736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6464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Blue flowers on a black background&#10;&#10;Description automatically generated with low confidence">
            <a:extLst>
              <a:ext uri="{FF2B5EF4-FFF2-40B4-BE49-F238E27FC236}">
                <a16:creationId xmlns:a16="http://schemas.microsoft.com/office/drawing/2014/main" id="{31456FA7-D066-0E48-9D9D-CC518A9476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56380" y="895910"/>
            <a:ext cx="4526761" cy="594137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0EEAAF1-67BF-4649-828D-B288FA5227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6323" y="925830"/>
            <a:ext cx="4511040" cy="592074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AAECBE6-4D37-6849-9247-27C8252B745A}"/>
              </a:ext>
            </a:extLst>
          </p:cNvPr>
          <p:cNvSpPr txBox="1"/>
          <p:nvPr/>
        </p:nvSpPr>
        <p:spPr>
          <a:xfrm>
            <a:off x="1542066" y="526578"/>
            <a:ext cx="3895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5 no </a:t>
            </a:r>
            <a:r>
              <a:rPr lang="en-US" dirty="0" err="1"/>
              <a:t>treatment_p</a:t>
            </a:r>
            <a:r>
              <a:rPr lang="en-US" dirty="0"/>
              <a:t>-ATM(S1981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1D1858-7299-DC49-A166-DF02AC8C8B90}"/>
              </a:ext>
            </a:extLst>
          </p:cNvPr>
          <p:cNvSpPr txBox="1"/>
          <p:nvPr/>
        </p:nvSpPr>
        <p:spPr>
          <a:xfrm>
            <a:off x="7130750" y="556498"/>
            <a:ext cx="3629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5 </a:t>
            </a:r>
            <a:r>
              <a:rPr lang="en-US" dirty="0" err="1"/>
              <a:t>Dox+auxin_p-ATM</a:t>
            </a:r>
            <a:r>
              <a:rPr lang="en-US" dirty="0"/>
              <a:t>(S1981)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5B302AB-85CB-134A-BBD9-0DD5F6C73132}"/>
              </a:ext>
            </a:extLst>
          </p:cNvPr>
          <p:cNvSpPr/>
          <p:nvPr/>
        </p:nvSpPr>
        <p:spPr>
          <a:xfrm>
            <a:off x="2514981" y="1189599"/>
            <a:ext cx="2183130" cy="18736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0272783-5779-9E48-B751-832EE82649F2}"/>
              </a:ext>
            </a:extLst>
          </p:cNvPr>
          <p:cNvSpPr/>
          <p:nvPr/>
        </p:nvSpPr>
        <p:spPr>
          <a:xfrm>
            <a:off x="7588050" y="3235568"/>
            <a:ext cx="2183130" cy="18736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116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80</Words>
  <Application>Microsoft Macintosh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iang-Chen Chou</dc:creator>
  <cp:lastModifiedBy>Hsiang-Chen Chou</cp:lastModifiedBy>
  <cp:revision>2</cp:revision>
  <dcterms:created xsi:type="dcterms:W3CDTF">2021-01-26T02:51:23Z</dcterms:created>
  <dcterms:modified xsi:type="dcterms:W3CDTF">2021-01-26T03:07:46Z</dcterms:modified>
</cp:coreProperties>
</file>